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media/image7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9D7BD4-BFD4-4976-8428-1CD09E63CB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315BC7-C074-4559-9BED-D2E349CEFD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2C84B-7989-406D-9F17-64063DC9C3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06D482-A618-48A3-859B-61394D7928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DB914-A7EF-4C5D-9FA0-75CE4F5FF3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06DF53-DB21-4E85-8408-63BFCF4C8F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902693-95D7-4F73-A6D6-FC3FB15882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0EC04E-24F8-495B-8DD0-4390AA56A6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B27058-1D60-4903-8D37-DE1C516C3C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6EF5C9-E284-4C19-8B46-42D9FEF25A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5DF7FF-E78C-4371-A664-D6EE14900F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452490-5836-4690-9AFB-F23A576A6C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768BBF-ED18-43B3-87A5-0E60F516911B}" type="slidenum">
              <a:rPr b="0" lang="ja-JP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4724280" y="4114800"/>
            <a:ext cx="2886120" cy="212580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304920" y="4114800"/>
            <a:ext cx="2894040" cy="212724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4724280" y="2055960"/>
            <a:ext cx="2882880" cy="213516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4"/>
          <a:stretch/>
        </p:blipFill>
        <p:spPr>
          <a:xfrm>
            <a:off x="304920" y="2082960"/>
            <a:ext cx="2886120" cy="212544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5"/>
          <a:stretch/>
        </p:blipFill>
        <p:spPr>
          <a:xfrm>
            <a:off x="4740120" y="0"/>
            <a:ext cx="2880000" cy="211932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6"/>
          <a:stretch/>
        </p:blipFill>
        <p:spPr>
          <a:xfrm>
            <a:off x="304920" y="152280"/>
            <a:ext cx="2894040" cy="212112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1602000" y="152280"/>
            <a:ext cx="40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ja-JP" sz="1200" spc="-1" strike="noStrike">
                <a:solidFill>
                  <a:srgbClr val="000000"/>
                </a:solidFill>
                <a:latin typeface="Times New Roman"/>
              </a:rPr>
              <a:t>Bi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6021720" y="152280"/>
            <a:ext cx="604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PIN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590120" y="2252520"/>
            <a:ext cx="36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ja-JP" sz="1200" spc="-1" strike="noStrike">
                <a:solidFill>
                  <a:srgbClr val="000000"/>
                </a:solidFill>
                <a:latin typeface="Times New Roman"/>
              </a:rPr>
              <a:t>to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6009120" y="2239920"/>
            <a:ext cx="43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Ire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461600" y="4343400"/>
            <a:ext cx="77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CG147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6022080" y="4343400"/>
            <a:ext cx="55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ja-JP" sz="1200" spc="-1" strike="noStrike">
                <a:solidFill>
                  <a:srgbClr val="000000"/>
                </a:solidFill>
                <a:latin typeface="Times New Roman"/>
              </a:rPr>
              <a:t>cath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98880" y="6172200"/>
            <a:ext cx="86648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5210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Supplementary Fig. 1. Expression of the other tested genes after the 7-day EF exposure in GD flies. No significant difference was observ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5210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fter EF exposure. Statistical data are expressed as the mean ± S.D. Statistical analysis was conducted using Student’s t-test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5210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 = 4 biological replicates for each group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16200000">
            <a:off x="-459000" y="835920"/>
            <a:ext cx="1559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Relative mRNA leve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16200000">
            <a:off x="3960360" y="823320"/>
            <a:ext cx="1559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Relative mRNA leve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rot="16200000">
            <a:off x="-463680" y="2804400"/>
            <a:ext cx="1559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Relative mRNA leve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rot="16200000">
            <a:off x="3955680" y="2779560"/>
            <a:ext cx="1559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Relative mRNA leve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rot="16200000">
            <a:off x="-459000" y="4868280"/>
            <a:ext cx="1559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Relative mRNA leve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rot="16200000">
            <a:off x="3960360" y="4856040"/>
            <a:ext cx="1559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Relative mRNA leve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"/>
          <p:cNvSpPr/>
          <p:nvPr/>
        </p:nvSpPr>
        <p:spPr>
          <a:xfrm>
            <a:off x="2657160" y="1219320"/>
            <a:ext cx="396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5210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Supplementary Table 1. Primer sequences used for qRT-PCR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" descr=""/>
          <p:cNvPicPr/>
          <p:nvPr/>
        </p:nvPicPr>
        <p:blipFill>
          <a:blip r:embed="rId1"/>
          <a:stretch/>
        </p:blipFill>
        <p:spPr>
          <a:xfrm>
            <a:off x="2664000" y="1738440"/>
            <a:ext cx="3816000" cy="2809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12-28T06:48:45Z</dcterms:created>
  <dc:creator>okano</dc:creator>
  <dc:description/>
  <dc:language>en-US</dc:language>
  <cp:lastModifiedBy>okano</cp:lastModifiedBy>
  <dcterms:modified xsi:type="dcterms:W3CDTF">2024-04-01T06:35:00Z</dcterms:modified>
  <cp:revision>6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